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</p:sldIdLst>
  <p:sldSz cx="1009015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73DC450-73EF-7240-8DA3-BFA7799C4BC7}" v="6" dt="2023-12-15T00:34:43.69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9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38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loria Salazar Aranda" userId="105f3e3b-7eeb-4e3d-89e2-71c09988a86c" providerId="ADAL" clId="{673DC450-73EF-7240-8DA3-BFA7799C4BC7}"/>
    <pc:docChg chg="modSld">
      <pc:chgData name="Gloria Salazar Aranda" userId="105f3e3b-7eeb-4e3d-89e2-71c09988a86c" providerId="ADAL" clId="{673DC450-73EF-7240-8DA3-BFA7799C4BC7}" dt="2023-12-18T16:25:36.970" v="6" actId="1076"/>
      <pc:docMkLst>
        <pc:docMk/>
      </pc:docMkLst>
      <pc:sldChg chg="modSp mod">
        <pc:chgData name="Gloria Salazar Aranda" userId="105f3e3b-7eeb-4e3d-89e2-71c09988a86c" providerId="ADAL" clId="{673DC450-73EF-7240-8DA3-BFA7799C4BC7}" dt="2023-12-18T16:25:36.970" v="6" actId="1076"/>
        <pc:sldMkLst>
          <pc:docMk/>
          <pc:sldMk cId="3737491760" sldId="256"/>
        </pc:sldMkLst>
        <pc:spChg chg="mod">
          <ac:chgData name="Gloria Salazar Aranda" userId="105f3e3b-7eeb-4e3d-89e2-71c09988a86c" providerId="ADAL" clId="{673DC450-73EF-7240-8DA3-BFA7799C4BC7}" dt="2023-12-18T16:25:36.970" v="6" actId="1076"/>
          <ac:spMkLst>
            <pc:docMk/>
            <pc:sldMk cId="3737491760" sldId="256"/>
            <ac:spMk id="2" creationId="{2E374F52-D344-F060-B0EC-6F6F05548A2A}"/>
          </ac:spMkLst>
        </pc:spChg>
        <pc:picChg chg="mod">
          <ac:chgData name="Gloria Salazar Aranda" userId="105f3e3b-7eeb-4e3d-89e2-71c09988a86c" providerId="ADAL" clId="{673DC450-73EF-7240-8DA3-BFA7799C4BC7}" dt="2023-12-18T16:25:33.603" v="5" actId="1076"/>
          <ac:picMkLst>
            <pc:docMk/>
            <pc:sldMk cId="3737491760" sldId="256"/>
            <ac:picMk id="5" creationId="{44B31E38-39FE-F5DB-1780-BE71AB6460E4}"/>
          </ac:picMkLst>
        </pc:picChg>
      </pc:sldChg>
      <pc:sldChg chg="modSp mod">
        <pc:chgData name="Gloria Salazar Aranda" userId="105f3e3b-7eeb-4e3d-89e2-71c09988a86c" providerId="ADAL" clId="{673DC450-73EF-7240-8DA3-BFA7799C4BC7}" dt="2023-12-18T16:25:18.066" v="3" actId="114"/>
        <pc:sldMkLst>
          <pc:docMk/>
          <pc:sldMk cId="3912039936" sldId="257"/>
        </pc:sldMkLst>
        <pc:spChg chg="mod">
          <ac:chgData name="Gloria Salazar Aranda" userId="105f3e3b-7eeb-4e3d-89e2-71c09988a86c" providerId="ADAL" clId="{673DC450-73EF-7240-8DA3-BFA7799C4BC7}" dt="2023-12-18T16:25:18.066" v="3" actId="114"/>
          <ac:spMkLst>
            <pc:docMk/>
            <pc:sldMk cId="3912039936" sldId="257"/>
            <ac:spMk id="7" creationId="{E4D72EFC-28A2-3BD1-86C7-010775A8EE27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761" y="1122363"/>
            <a:ext cx="8576628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1269" y="3602038"/>
            <a:ext cx="7567613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595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143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20764" y="365125"/>
            <a:ext cx="2175689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698" y="365125"/>
            <a:ext cx="640093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706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959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8443" y="1709740"/>
            <a:ext cx="8702754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8443" y="4589465"/>
            <a:ext cx="8702754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431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698" y="1825625"/>
            <a:ext cx="4288314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8138" y="1825625"/>
            <a:ext cx="4288314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388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5012" y="365127"/>
            <a:ext cx="8702754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5013" y="1681163"/>
            <a:ext cx="426860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5013" y="2505075"/>
            <a:ext cx="4268606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8139" y="1681163"/>
            <a:ext cx="428962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8139" y="2505075"/>
            <a:ext cx="428962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263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273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204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5012" y="457200"/>
            <a:ext cx="32543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9628" y="987427"/>
            <a:ext cx="510813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5012" y="2057400"/>
            <a:ext cx="32543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76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5012" y="457200"/>
            <a:ext cx="32543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9628" y="987427"/>
            <a:ext cx="5108138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5012" y="2057400"/>
            <a:ext cx="32543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039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698" y="365127"/>
            <a:ext cx="8702754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698" y="1825625"/>
            <a:ext cx="8702754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698" y="6356352"/>
            <a:ext cx="227028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5DD63-DDE0-4731-8C15-62DA2511EFD0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42362" y="6356352"/>
            <a:ext cx="340542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26168" y="6356352"/>
            <a:ext cx="227028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A4AF4-A6A5-464C-B50D-7548CD4A4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611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B5BADEA-E93A-BAB0-ED05-934580BFD1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3994" y="1104901"/>
            <a:ext cx="5581253" cy="263919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4D72EFC-28A2-3BD1-86C7-010775A8EE27}"/>
              </a:ext>
            </a:extLst>
          </p:cNvPr>
          <p:cNvSpPr txBox="1"/>
          <p:nvPr/>
        </p:nvSpPr>
        <p:spPr>
          <a:xfrm>
            <a:off x="867775" y="3898211"/>
            <a:ext cx="841710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dy weight, food, and water intake in HFD-treated mice. Body weight (A and D), water (B and E), and food intake (C and F) were measured weekly in male and female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dipoq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dipoq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dipoq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ce throughout HFD treatment (5 weeks). * denotes p &lt; 0.05 compared to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poe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dipoq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s.</a:t>
            </a:r>
          </a:p>
        </p:txBody>
      </p:sp>
    </p:spTree>
    <p:extLst>
      <p:ext uri="{BB962C8B-B14F-4D97-AF65-F5344CB8AC3E}">
        <p14:creationId xmlns:p14="http://schemas.microsoft.com/office/powerpoint/2010/main" val="3912039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4B31E38-39FE-F5DB-1780-BE71AB6460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52" y="553747"/>
            <a:ext cx="7472015" cy="622958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E374F52-D344-F060-B0EC-6F6F05548A2A}"/>
              </a:ext>
            </a:extLst>
          </p:cNvPr>
          <p:cNvSpPr txBox="1"/>
          <p:nvPr/>
        </p:nvSpPr>
        <p:spPr>
          <a:xfrm>
            <a:off x="583188" y="276748"/>
            <a:ext cx="6040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Correlation analysis of plaque with sex, age and pro-atherogenic molecules</a:t>
            </a:r>
          </a:p>
        </p:txBody>
      </p:sp>
    </p:spTree>
    <p:extLst>
      <p:ext uri="{BB962C8B-B14F-4D97-AF65-F5344CB8AC3E}">
        <p14:creationId xmlns:p14="http://schemas.microsoft.com/office/powerpoint/2010/main" val="3737491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8</TotalTime>
  <Words>91</Words>
  <Application>Microsoft Office PowerPoint</Application>
  <PresentationFormat>Custom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y Cullen</dc:creator>
  <cp:lastModifiedBy>MDPI</cp:lastModifiedBy>
  <cp:revision>3</cp:revision>
  <dcterms:created xsi:type="dcterms:W3CDTF">2023-11-22T18:51:31Z</dcterms:created>
  <dcterms:modified xsi:type="dcterms:W3CDTF">2023-12-19T07:33:56Z</dcterms:modified>
</cp:coreProperties>
</file>